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>
        <p:scale>
          <a:sx n="66" d="100"/>
          <a:sy n="66" d="100"/>
        </p:scale>
        <p:origin x="1572" y="9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440A40-2A53-5921-95E0-AB43A47B18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DDF08C2-B576-32AD-5FFF-63ED575348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BD9E5F-0A15-1CC3-4753-820657D45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0C40-2F8B-4875-874B-E951B4C30FB6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542E13-FB6F-9E1A-4619-F06FD2D7D0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F9A065-2E65-2AD8-85C1-58BE7EF8E4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BCA2-2E46-4AC6-BC66-88736B98D2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8305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169461-B670-03AD-D5BB-1C1DA6605E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A139F5-DC1F-C01B-95D2-B654A7577F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E43DEA-22D6-5D3F-4AC6-ADA66504D8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0C40-2F8B-4875-874B-E951B4C30FB6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C32CAC-8FAE-AF32-D8DE-F257B2684F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8093D4-99FC-3168-52DF-7ED58FEA1E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BCA2-2E46-4AC6-BC66-88736B98D2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4826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D7F3EA9-8F7D-92B2-F2C8-461343D306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9E8080-E9FA-B852-7D0D-1DBD0BDB22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7A446F-281A-21CD-2F22-158C3B0CE3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0C40-2F8B-4875-874B-E951B4C30FB6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D26396-08AE-7B53-8008-6906D7F3A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2C94A0-DE74-29A6-1FEA-94E2F6EEC1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BCA2-2E46-4AC6-BC66-88736B98D2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735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E97BBD-CE1E-29F5-8049-E94EB115C1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ACC6A9-B1C2-C14E-9D42-E90A6A434D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0DF93C-5BBE-5198-4FF5-BFA398480E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0C40-2F8B-4875-874B-E951B4C30FB6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E94031-1D6F-74E9-1736-AEC0122B48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EFAC20-F913-0FA1-2CFF-AB606B1BF9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BCA2-2E46-4AC6-BC66-88736B98D2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491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8F0810-EB13-87B1-E783-A223C37479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D476E9-2BB8-3512-0754-46E993C2E7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1676DE-7BDB-3AEA-7D13-C4EA7A881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0C40-2F8B-4875-874B-E951B4C30FB6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AFB66C-63E4-6917-EB6F-67D46304D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C9B3D0-FD07-F492-044D-32B53C842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BCA2-2E46-4AC6-BC66-88736B98D2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8904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8113B-16C8-5376-3847-255A29F6D8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627F2F-8B1D-36AE-2662-A6C52F3058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AEFCB5-237A-B674-9270-084A283395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EC6602-0E2D-4DB0-7646-AEBA999970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0C40-2F8B-4875-874B-E951B4C30FB6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42B72D-CE2F-6911-6B8B-7220FF0E7F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0E4DE0-8748-7B49-2C65-CE9CC3B98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BCA2-2E46-4AC6-BC66-88736B98D2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9711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9E647C-D949-3B4C-91F6-BCDDAD12E1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795063-737F-278A-E71D-068D667B4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5D2C29-911C-5655-D232-95580F7A03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4AA1895-9CF8-3BE9-2EB5-D6458E43B2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9968D70-31AB-E347-BE33-D38295BCD8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34ECF7-C688-F9F0-A44E-5D3290DA3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0C40-2F8B-4875-874B-E951B4C30FB6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FF8C881-A7F6-1302-9D02-54282B28C2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D66700-6F31-B95F-BA4F-FEB07E629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BCA2-2E46-4AC6-BC66-88736B98D2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87996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B12D0E-4ACD-0397-A366-E2CE0CAFC0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BFBBDE1-22F2-9B26-77E8-F37289FBC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0C40-2F8B-4875-874B-E951B4C30FB6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89D9871-83D8-48EA-9E8E-AB3A027F6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4529E6-794B-71F6-91F1-3C645940B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BCA2-2E46-4AC6-BC66-88736B98D2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4593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BCE541E-6EC7-14AC-2CB4-575ED4D70C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0C40-2F8B-4875-874B-E951B4C30FB6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B9ED86-CC06-0C8D-93CF-3EC17031D4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7F05EEA-B4C9-51CE-6D53-57CD532DB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BCA2-2E46-4AC6-BC66-88736B98D2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3957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D598A7-A809-74C2-3466-965F806809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70ACFE-877F-C184-E71B-DCC1C16EAB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EE10A6-E099-2260-3E00-551BB5EAAA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764FB7-C045-72DD-9625-CF5AD5D01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0C40-2F8B-4875-874B-E951B4C30FB6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2727B2-6A46-651A-5229-9482E1E7B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001F8D-0C1D-3E40-7DC0-82A1EDB3B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BCA2-2E46-4AC6-BC66-88736B98D2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2363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C5998A-BB22-FD40-656A-8753C6B930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FDFE0B2-49C6-F565-89DE-0B85A1BD5B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50D4E2-6381-41BE-D904-C4697927B9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4D2EDE-30FF-E466-0E23-842F77D75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0C40-2F8B-4875-874B-E951B4C30FB6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1BA8C7-CF3B-D67A-F134-1400903F8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E2F9B1-19E0-083C-A334-156FB60F3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3BCA2-2E46-4AC6-BC66-88736B98D2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5685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A6D2475-73B4-737B-9917-7C4D51D635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199DBE-A171-A5AB-D507-691C5CCDDE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4322AF-E083-01C1-3243-3DB12AD052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A300C40-2F8B-4875-874B-E951B4C30FB6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E945F8-3A09-FFD1-21AC-309782DD30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9ABB67-A61B-F57C-D32F-0C590B3361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503BCA2-2E46-4AC6-BC66-88736B98D2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1215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B776072F-6F23-D7D9-5DAA-1EC2533197B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5248"/>
          <a:stretch/>
        </p:blipFill>
        <p:spPr>
          <a:xfrm>
            <a:off x="994510" y="1752521"/>
            <a:ext cx="2142461" cy="288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4169D6C-1A8D-A831-6970-879E3F039A99}"/>
              </a:ext>
            </a:extLst>
          </p:cNvPr>
          <p:cNvSpPr txBox="1"/>
          <p:nvPr/>
        </p:nvSpPr>
        <p:spPr>
          <a:xfrm>
            <a:off x="99207" y="2142214"/>
            <a:ext cx="9653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dirty="0"/>
              <a:t>Mock</a:t>
            </a:r>
          </a:p>
          <a:p>
            <a:pPr algn="r"/>
            <a:r>
              <a:rPr lang="en-GB" dirty="0"/>
              <a:t>medium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45EDF80-6434-97CB-7A62-67EB11A7726C}"/>
              </a:ext>
            </a:extLst>
          </p:cNvPr>
          <p:cNvSpPr txBox="1"/>
          <p:nvPr/>
        </p:nvSpPr>
        <p:spPr>
          <a:xfrm>
            <a:off x="-276307" y="3513548"/>
            <a:ext cx="133722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dirty="0"/>
              <a:t>Conditioned</a:t>
            </a:r>
          </a:p>
          <a:p>
            <a:pPr algn="r"/>
            <a:r>
              <a:rPr lang="en-GB" dirty="0"/>
              <a:t>medium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279EF38-3351-3897-6290-1C02E36D0AD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5248"/>
          <a:stretch/>
        </p:blipFill>
        <p:spPr>
          <a:xfrm>
            <a:off x="7645735" y="1674610"/>
            <a:ext cx="2142461" cy="28800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C08EF4B-7C0B-0ED1-CCBE-5AFD090F01D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4583"/>
          <a:stretch/>
        </p:blipFill>
        <p:spPr>
          <a:xfrm>
            <a:off x="3212853" y="1752521"/>
            <a:ext cx="2161538" cy="2880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0D9AC8F-6F23-860B-59EF-D1DD3B13717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5248"/>
          <a:stretch/>
        </p:blipFill>
        <p:spPr>
          <a:xfrm>
            <a:off x="5421813" y="1717401"/>
            <a:ext cx="2142461" cy="28800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8C48D15C-EC43-E3B5-3B97-7836C118A10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5485"/>
          <a:stretch/>
        </p:blipFill>
        <p:spPr>
          <a:xfrm rot="5400000">
            <a:off x="10222896" y="2786632"/>
            <a:ext cx="1440000" cy="2169345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35B6910E-6CFA-2941-94CC-9B7AB3661E1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25753"/>
          <a:stretch/>
        </p:blipFill>
        <p:spPr>
          <a:xfrm rot="5400000">
            <a:off x="10226800" y="1386875"/>
            <a:ext cx="1440000" cy="2161538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6DB8E851-68A0-68A6-41A0-48C289CBF068}"/>
              </a:ext>
            </a:extLst>
          </p:cNvPr>
          <p:cNvSpPr txBox="1"/>
          <p:nvPr/>
        </p:nvSpPr>
        <p:spPr>
          <a:xfrm>
            <a:off x="11525471" y="2676535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#5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46FE4595-AECA-E912-ED47-FDA84D3CF4EE}"/>
              </a:ext>
            </a:extLst>
          </p:cNvPr>
          <p:cNvGrpSpPr/>
          <p:nvPr/>
        </p:nvGrpSpPr>
        <p:grpSpPr>
          <a:xfrm>
            <a:off x="994510" y="1007267"/>
            <a:ext cx="2041336" cy="813920"/>
            <a:chOff x="994510" y="983735"/>
            <a:chExt cx="2041336" cy="813920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75D40AB-17B0-3950-B560-D16EFD3F03CC}"/>
                </a:ext>
              </a:extLst>
            </p:cNvPr>
            <p:cNvSpPr txBox="1"/>
            <p:nvPr/>
          </p:nvSpPr>
          <p:spPr>
            <a:xfrm>
              <a:off x="1211150" y="1414227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-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05DD8A6-F7C3-A032-47D2-11432FB6F8E2}"/>
                </a:ext>
              </a:extLst>
            </p:cNvPr>
            <p:cNvSpPr txBox="1"/>
            <p:nvPr/>
          </p:nvSpPr>
          <p:spPr>
            <a:xfrm>
              <a:off x="1578266" y="1418190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Na</a:t>
              </a:r>
              <a:r>
                <a:rPr lang="en-GB" baseline="-25000" dirty="0"/>
                <a:t>2</a:t>
              </a:r>
              <a:r>
                <a:rPr lang="en-GB" dirty="0"/>
                <a:t>SeO</a:t>
              </a:r>
              <a:r>
                <a:rPr lang="en-GB" baseline="-25000" dirty="0"/>
                <a:t>3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9531AE9-344A-9B77-7302-17829219D694}"/>
                </a:ext>
              </a:extLst>
            </p:cNvPr>
            <p:cNvSpPr txBox="1"/>
            <p:nvPr/>
          </p:nvSpPr>
          <p:spPr>
            <a:xfrm>
              <a:off x="2553213" y="1428323"/>
              <a:ext cx="4826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Fer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115632C-A097-563B-27C6-9F5E594966EF}"/>
                </a:ext>
              </a:extLst>
            </p:cNvPr>
            <p:cNvSpPr txBox="1"/>
            <p:nvPr/>
          </p:nvSpPr>
          <p:spPr>
            <a:xfrm>
              <a:off x="1690476" y="983735"/>
              <a:ext cx="7505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Exp#1</a:t>
              </a: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D3B377E9-22AA-4482-82FA-9290817BEF0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94510" y="1414227"/>
              <a:ext cx="20413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B1A21122-C99A-62E4-9CD9-F446A969373D}"/>
              </a:ext>
            </a:extLst>
          </p:cNvPr>
          <p:cNvGrpSpPr/>
          <p:nvPr/>
        </p:nvGrpSpPr>
        <p:grpSpPr>
          <a:xfrm>
            <a:off x="3247548" y="1007267"/>
            <a:ext cx="2041336" cy="813920"/>
            <a:chOff x="994510" y="983735"/>
            <a:chExt cx="2041336" cy="813920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D1A8F23-E19A-2BF9-D8E4-07045A587695}"/>
                </a:ext>
              </a:extLst>
            </p:cNvPr>
            <p:cNvSpPr txBox="1"/>
            <p:nvPr/>
          </p:nvSpPr>
          <p:spPr>
            <a:xfrm>
              <a:off x="1211150" y="1414227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-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100D783-CD50-5D50-94AE-9EB1E03B086A}"/>
                </a:ext>
              </a:extLst>
            </p:cNvPr>
            <p:cNvSpPr txBox="1"/>
            <p:nvPr/>
          </p:nvSpPr>
          <p:spPr>
            <a:xfrm>
              <a:off x="1578266" y="1418190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Na</a:t>
              </a:r>
              <a:r>
                <a:rPr lang="en-GB" baseline="-25000" dirty="0"/>
                <a:t>2</a:t>
              </a:r>
              <a:r>
                <a:rPr lang="en-GB" dirty="0"/>
                <a:t>SeO</a:t>
              </a:r>
              <a:r>
                <a:rPr lang="en-GB" baseline="-25000" dirty="0"/>
                <a:t>3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32ADA2F-1132-C19D-9F9F-E4289DAC7C60}"/>
                </a:ext>
              </a:extLst>
            </p:cNvPr>
            <p:cNvSpPr txBox="1"/>
            <p:nvPr/>
          </p:nvSpPr>
          <p:spPr>
            <a:xfrm>
              <a:off x="2553213" y="1428323"/>
              <a:ext cx="4826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Fer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85B522F-DEA8-23A7-4927-04D3EA535BDA}"/>
                </a:ext>
              </a:extLst>
            </p:cNvPr>
            <p:cNvSpPr txBox="1"/>
            <p:nvPr/>
          </p:nvSpPr>
          <p:spPr>
            <a:xfrm>
              <a:off x="1690476" y="983735"/>
              <a:ext cx="7505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Exp#2</a:t>
              </a: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9F2682B3-13A6-F1E1-B635-6C728BD765C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94510" y="1414227"/>
              <a:ext cx="20413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6E8B4D24-13D4-8320-35AB-AA1BAE92265D}"/>
              </a:ext>
            </a:extLst>
          </p:cNvPr>
          <p:cNvGrpSpPr/>
          <p:nvPr/>
        </p:nvGrpSpPr>
        <p:grpSpPr>
          <a:xfrm>
            <a:off x="5475516" y="1007267"/>
            <a:ext cx="2041336" cy="813920"/>
            <a:chOff x="994510" y="983735"/>
            <a:chExt cx="2041336" cy="813920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41ACCDE-4E3A-935E-5D04-2F0A7230B19D}"/>
                </a:ext>
              </a:extLst>
            </p:cNvPr>
            <p:cNvSpPr txBox="1"/>
            <p:nvPr/>
          </p:nvSpPr>
          <p:spPr>
            <a:xfrm>
              <a:off x="1211150" y="1414227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-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B6FF021-BF8A-D8FA-2405-DF399DCADFBB}"/>
                </a:ext>
              </a:extLst>
            </p:cNvPr>
            <p:cNvSpPr txBox="1"/>
            <p:nvPr/>
          </p:nvSpPr>
          <p:spPr>
            <a:xfrm>
              <a:off x="1578266" y="1418190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Na</a:t>
              </a:r>
              <a:r>
                <a:rPr lang="en-GB" baseline="-25000" dirty="0"/>
                <a:t>2</a:t>
              </a:r>
              <a:r>
                <a:rPr lang="en-GB" dirty="0"/>
                <a:t>SeO</a:t>
              </a:r>
              <a:r>
                <a:rPr lang="en-GB" baseline="-25000" dirty="0"/>
                <a:t>3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9F32D3D9-48D4-C968-8D22-1557BCC7F4BA}"/>
                </a:ext>
              </a:extLst>
            </p:cNvPr>
            <p:cNvSpPr txBox="1"/>
            <p:nvPr/>
          </p:nvSpPr>
          <p:spPr>
            <a:xfrm>
              <a:off x="2553213" y="1428323"/>
              <a:ext cx="4826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Fer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E3D2FD2-6F9C-BC27-997A-B34880186D08}"/>
                </a:ext>
              </a:extLst>
            </p:cNvPr>
            <p:cNvSpPr txBox="1"/>
            <p:nvPr/>
          </p:nvSpPr>
          <p:spPr>
            <a:xfrm>
              <a:off x="1690476" y="983735"/>
              <a:ext cx="7505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Exp#3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0C197C3B-2032-72CB-33B1-E6BC1B83E05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94510" y="1414227"/>
              <a:ext cx="20413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49884E07-1669-73D7-5DF8-DCD2B1264AAA}"/>
              </a:ext>
            </a:extLst>
          </p:cNvPr>
          <p:cNvGrpSpPr/>
          <p:nvPr/>
        </p:nvGrpSpPr>
        <p:grpSpPr>
          <a:xfrm>
            <a:off x="7702770" y="1007267"/>
            <a:ext cx="2041336" cy="813920"/>
            <a:chOff x="994510" y="983735"/>
            <a:chExt cx="2041336" cy="813920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FED20CB-4663-EE6E-FFF0-189CFFDEC8DD}"/>
                </a:ext>
              </a:extLst>
            </p:cNvPr>
            <p:cNvSpPr txBox="1"/>
            <p:nvPr/>
          </p:nvSpPr>
          <p:spPr>
            <a:xfrm>
              <a:off x="1211150" y="1414227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-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EFB6C26-4B76-20AE-3201-60210CF6449D}"/>
                </a:ext>
              </a:extLst>
            </p:cNvPr>
            <p:cNvSpPr txBox="1"/>
            <p:nvPr/>
          </p:nvSpPr>
          <p:spPr>
            <a:xfrm>
              <a:off x="1578266" y="1418190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Na</a:t>
              </a:r>
              <a:r>
                <a:rPr lang="en-GB" baseline="-25000" dirty="0"/>
                <a:t>2</a:t>
              </a:r>
              <a:r>
                <a:rPr lang="en-GB" dirty="0"/>
                <a:t>SeO</a:t>
              </a:r>
              <a:r>
                <a:rPr lang="en-GB" baseline="-25000" dirty="0"/>
                <a:t>3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82D816DC-5B46-1224-44E2-1597249767F6}"/>
                </a:ext>
              </a:extLst>
            </p:cNvPr>
            <p:cNvSpPr txBox="1"/>
            <p:nvPr/>
          </p:nvSpPr>
          <p:spPr>
            <a:xfrm>
              <a:off x="2553213" y="1428323"/>
              <a:ext cx="4826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Fer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F063FC15-EB8F-5CEB-66D2-529230D1DBFD}"/>
                </a:ext>
              </a:extLst>
            </p:cNvPr>
            <p:cNvSpPr txBox="1"/>
            <p:nvPr/>
          </p:nvSpPr>
          <p:spPr>
            <a:xfrm>
              <a:off x="1690476" y="983735"/>
              <a:ext cx="7505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Exp#4</a:t>
              </a:r>
            </a:p>
          </p:txBody>
        </p: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403A3DEA-4908-2B6C-4558-81768E77343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94510" y="1414227"/>
              <a:ext cx="20413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70A4A871-0C3D-319C-0423-541F5A4F5F61}"/>
              </a:ext>
            </a:extLst>
          </p:cNvPr>
          <p:cNvGrpSpPr/>
          <p:nvPr/>
        </p:nvGrpSpPr>
        <p:grpSpPr>
          <a:xfrm>
            <a:off x="9893226" y="1007267"/>
            <a:ext cx="2041336" cy="813920"/>
            <a:chOff x="994510" y="983735"/>
            <a:chExt cx="2041336" cy="813920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456F724E-D839-527C-D43B-E555B03181A1}"/>
                </a:ext>
              </a:extLst>
            </p:cNvPr>
            <p:cNvSpPr txBox="1"/>
            <p:nvPr/>
          </p:nvSpPr>
          <p:spPr>
            <a:xfrm>
              <a:off x="1211150" y="1414227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-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A47A1A8B-94B4-8045-1FF3-5A42EC9BDE79}"/>
                </a:ext>
              </a:extLst>
            </p:cNvPr>
            <p:cNvSpPr txBox="1"/>
            <p:nvPr/>
          </p:nvSpPr>
          <p:spPr>
            <a:xfrm>
              <a:off x="1578266" y="1418190"/>
              <a:ext cx="974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Na</a:t>
              </a:r>
              <a:r>
                <a:rPr lang="en-GB" baseline="-25000" dirty="0"/>
                <a:t>2</a:t>
              </a:r>
              <a:r>
                <a:rPr lang="en-GB" dirty="0"/>
                <a:t>SeO</a:t>
              </a:r>
              <a:r>
                <a:rPr lang="en-GB" baseline="-25000" dirty="0"/>
                <a:t>3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EDA8B504-E443-A6C6-8830-0186A6DA3D56}"/>
                </a:ext>
              </a:extLst>
            </p:cNvPr>
            <p:cNvSpPr txBox="1"/>
            <p:nvPr/>
          </p:nvSpPr>
          <p:spPr>
            <a:xfrm>
              <a:off x="2553213" y="1428323"/>
              <a:ext cx="4826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Fer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13ABDFAF-21B6-0A21-4103-E03186DD550A}"/>
                </a:ext>
              </a:extLst>
            </p:cNvPr>
            <p:cNvSpPr txBox="1"/>
            <p:nvPr/>
          </p:nvSpPr>
          <p:spPr>
            <a:xfrm>
              <a:off x="1690476" y="983735"/>
              <a:ext cx="7505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Exp#5</a:t>
              </a:r>
            </a:p>
          </p:txBody>
        </p: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D970CE86-8631-1794-39F1-4CAF9EFC713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94510" y="1414227"/>
              <a:ext cx="20413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ED46BA79-B57F-556B-CB83-4FB5B7E110B3}"/>
              </a:ext>
            </a:extLst>
          </p:cNvPr>
          <p:cNvCxnSpPr>
            <a:cxnSpLocks/>
            <a:stCxn id="14" idx="1"/>
          </p:cNvCxnSpPr>
          <p:nvPr/>
        </p:nvCxnSpPr>
        <p:spPr>
          <a:xfrm flipH="1" flipV="1">
            <a:off x="981023" y="1821187"/>
            <a:ext cx="13487" cy="137133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0E6D22EF-7D1E-F606-7926-1ED2AC04D963}"/>
              </a:ext>
            </a:extLst>
          </p:cNvPr>
          <p:cNvCxnSpPr>
            <a:cxnSpLocks/>
          </p:cNvCxnSpPr>
          <p:nvPr/>
        </p:nvCxnSpPr>
        <p:spPr>
          <a:xfrm flipH="1" flipV="1">
            <a:off x="993913" y="3260035"/>
            <a:ext cx="7987" cy="133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10527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36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1</cp:revision>
  <dcterms:created xsi:type="dcterms:W3CDTF">2024-06-06T13:36:05Z</dcterms:created>
  <dcterms:modified xsi:type="dcterms:W3CDTF">2024-06-06T14:04:56Z</dcterms:modified>
</cp:coreProperties>
</file>